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60" r:id="rId4"/>
    <p:sldId id="263" r:id="rId5"/>
    <p:sldId id="261" r:id="rId6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87" autoAdjust="0"/>
    <p:restoredTop sz="94660"/>
  </p:normalViewPr>
  <p:slideViewPr>
    <p:cSldViewPr snapToGrid="0">
      <p:cViewPr varScale="1">
        <p:scale>
          <a:sx n="62" d="100"/>
          <a:sy n="62" d="100"/>
        </p:scale>
        <p:origin x="229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9877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03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0269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9719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5787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8090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817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7601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307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600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8203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70DD8-E948-40D4-B234-0871BBEE6F8B}" type="datetimeFigureOut">
              <a:rPr lang="zh-CN" altLang="en-US" smtClean="0"/>
              <a:t>2018/4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CF01F-5966-419C-87BE-5E00D4130C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8504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239556" y="7976919"/>
            <a:ext cx="6422502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linear of markers between genetic positon on linkage map and physical position on the genome. (A). SE population. The X-axis refers to genetic distance of each linkage, the Y-axis refers to physical length of each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kage 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cattered points showed the linear relation between the genetic position and the physicals position of each marker. (B).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W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. 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187" y="98854"/>
            <a:ext cx="4885367" cy="71226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9927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6" name="矩形 2365"/>
          <p:cNvSpPr/>
          <p:nvPr/>
        </p:nvSpPr>
        <p:spPr>
          <a:xfrm>
            <a:off x="289263" y="7850607"/>
            <a:ext cx="634013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</a:rPr>
              <a:t>Supplementary Fig. 2 </a:t>
            </a:r>
            <a:r>
              <a:rPr lang="en-US" altLang="zh-CN" sz="1200" dirty="0">
                <a:latin typeface="Times New Roman" panose="02020603050405020304" pitchFamily="18" charset="0"/>
              </a:rPr>
              <a:t>Correlation analysis result among flowering time, maturity time and reproduction period from the SE RIL population in two growth seasons and the average data of the two seasons. (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bin, 2016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bin, 2017. (C). Average data of Harbin, 2016 and Harbin, 2017.  R1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to flowering, R8 represented time to maturity and RP represented reproductive period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/>
          </a:p>
        </p:txBody>
      </p:sp>
      <p:pic>
        <p:nvPicPr>
          <p:cNvPr id="2367" name="图片 236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178" y="151471"/>
            <a:ext cx="6641254" cy="716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14317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9" name="矩形 1948"/>
          <p:cNvSpPr/>
          <p:nvPr/>
        </p:nvSpPr>
        <p:spPr>
          <a:xfrm>
            <a:off x="223157" y="7487921"/>
            <a:ext cx="638447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</a:rPr>
              <a:t>Supplementary Fig. 3 </a:t>
            </a:r>
            <a:r>
              <a:rPr lang="en-US" altLang="zh-CN" sz="1200" dirty="0">
                <a:latin typeface="Times New Roman" panose="02020603050405020304" pitchFamily="18" charset="0"/>
              </a:rPr>
              <a:t>Correlation analysis result among flowering time, maturity time and reproduction period from the DW RIL population in two growth seasons and the average data of the two seasons. (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bin, 2016.  (B)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bin, 2017. (C). Average data of Harbin, 2016 and Harbin, 2017.  R1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to flowering, R8 represented time to maturity and RP represented reproductive period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/>
          </a:p>
        </p:txBody>
      </p:sp>
      <p:pic>
        <p:nvPicPr>
          <p:cNvPr id="1950" name="图片 194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59" y="578101"/>
            <a:ext cx="6696000" cy="62685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69249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4" name="文本框 663"/>
          <p:cNvSpPr txBox="1"/>
          <p:nvPr/>
        </p:nvSpPr>
        <p:spPr>
          <a:xfrm>
            <a:off x="250612" y="8336340"/>
            <a:ext cx="635793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Enlarged figures about LOD value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stable QTLs detected by both MQM and CIM method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x-none" altLang="zh-CN" sz="1200" dirty="0"/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C LOD values of QTLs on chromosome04 of R1, R8 and RP traits in DW population. D-H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D values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TL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06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R1,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8 and RP traits; chromosome11 of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8 traits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chromosome16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1 traits. </a:t>
            </a:r>
            <a:r>
              <a:rPr lang="x-none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QM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x-none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iple-QTL model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CIM: composit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al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ping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isk represents the threshold calculated by permutation test at a significance level of P&lt;0.05, n=1000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072" y="556052"/>
            <a:ext cx="5708789" cy="78282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00326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56932" y="3244335"/>
            <a:ext cx="59554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</a:rPr>
              <a:t>Supplementary Fig. </a:t>
            </a:r>
            <a:r>
              <a:rPr lang="en-US" altLang="zh-CN" sz="1200" b="1" dirty="0" smtClean="0">
                <a:latin typeface="Times New Roman" panose="02020603050405020304" pitchFamily="18" charset="0"/>
              </a:rPr>
              <a:t>5</a:t>
            </a:r>
            <a:r>
              <a:rPr lang="en-US" altLang="zh-CN" sz="1200" dirty="0" smtClean="0">
                <a:latin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</a:rPr>
              <a:t>Polymorphism at </a:t>
            </a:r>
            <a:r>
              <a:rPr lang="en-US" altLang="zh-CN" sz="1200" i="1" dirty="0">
                <a:latin typeface="Times New Roman" panose="02020603050405020304" pitchFamily="18" charset="0"/>
              </a:rPr>
              <a:t>Dt1 </a:t>
            </a:r>
            <a:r>
              <a:rPr lang="en-US" altLang="zh-CN" sz="1200" dirty="0">
                <a:latin typeface="Times New Roman" panose="02020603050405020304" pitchFamily="18" charset="0"/>
              </a:rPr>
              <a:t>loci between Suinong14 and Enrei. SN14 is the </a:t>
            </a:r>
          </a:p>
          <a:p>
            <a:r>
              <a:rPr lang="en-US" altLang="zh-CN" sz="1200" dirty="0">
                <a:latin typeface="Times New Roman" panose="02020603050405020304" pitchFamily="18" charset="0"/>
              </a:rPr>
              <a:t> abbreviation of Suinong14.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989" y="1278418"/>
            <a:ext cx="6269736" cy="1078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93655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25</TotalTime>
  <Words>343</Words>
  <Application>Microsoft Office PowerPoint</Application>
  <PresentationFormat>A4 纸张(210x297 毫米)</PresentationFormat>
  <Paragraphs>6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16</cp:revision>
  <dcterms:created xsi:type="dcterms:W3CDTF">2017-11-02T02:35:54Z</dcterms:created>
  <dcterms:modified xsi:type="dcterms:W3CDTF">2018-04-24T02:20:28Z</dcterms:modified>
</cp:coreProperties>
</file>